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4EBE4C-29A0-4B60-A35B-94B6D658112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D32729-F757-4CCD-A109-5F97FE350EF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54AD85-05F4-480C-AD94-68616D6F5DA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72BD3C-BD95-4419-A3BE-8170F50F161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8F3CE3-F35E-4750-8224-F7CF468D051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78D225-50EB-4273-9941-F53EE924153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D16AC1-36CE-41FC-8896-137EEF8DBDD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3B91D5-8B52-408D-8F10-A090AD48270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584E07-FB9F-4875-9A31-25BC5AB5DFA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8C2BE5-8241-43E8-8769-80F3AD2FF2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9171D3-65CA-48B8-B543-E8D016794F9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856081-74E9-4A6D-9C3A-8CB75EE906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i-FI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i-FI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00F0923-5B32-4ECB-BEE8-0F874CF04F5C}" type="slidenum">
              <a:rPr b="0" lang="fi-FI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307800" y="2732040"/>
          <a:ext cx="8569440" cy="1692360"/>
        </p:xfrm>
        <a:graphic>
          <a:graphicData uri="http://schemas.openxmlformats.org/drawingml/2006/table">
            <a:tbl>
              <a:tblPr/>
              <a:tblGrid>
                <a:gridCol w="2237040"/>
                <a:gridCol w="966600"/>
                <a:gridCol w="970200"/>
                <a:gridCol w="1042920"/>
                <a:gridCol w="745920"/>
                <a:gridCol w="1230480"/>
                <a:gridCol w="1376280"/>
              </a:tblGrid>
              <a:tr h="710640">
                <a:tc>
                  <a:txBody>
                    <a:bodyPr lIns="47520" rIns="47520" tIns="0" bIns="0" anchor="t">
                      <a:noAutofit/>
                    </a:bodyPr>
                    <a:p>
                      <a:pPr algn="just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7520" marR="4752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47520" rIns="4752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CV VP1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FN-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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pg/mL±S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7520" marR="4752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47520" rIns="4752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CV VP1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L-10 pg/mL±S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7520" marR="4752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7520" rIns="4752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ndid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FN-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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pg/mL±S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7520" marR="4752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7520" rIns="4752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ndid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L-10 pg/mL±S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7520" marR="4752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4840">
                <a:tc>
                  <a:txBody>
                    <a:bodyPr lIns="47520" rIns="475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ntigen concentration (µg/ml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7520" marR="475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7520" rIns="4752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7520" marR="475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7520" rIns="4752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7520" marR="475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7520" rIns="4752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7520" marR="475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7520" rIns="4752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7520" marR="475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7520" rIns="4752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7520" marR="475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7520" rIns="4752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7520" marR="475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27160">
                <a:tc>
                  <a:txBody>
                    <a:bodyPr lIns="47520" rIns="47520" tIns="0" bIns="0" anchor="t">
                      <a:noAutofit/>
                    </a:bodyPr>
                    <a:p>
                      <a:pPr algn="just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CV seropositiv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7520" marR="47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7520" rIns="4752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1.2±177.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7520" marR="47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7520" rIns="4752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8.7±162.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7520" marR="47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7520" rIns="4752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5.50±105.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7520" marR="47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7520" rIns="4752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3.6±30.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7520" marR="47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7520" rIns="4752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385±181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7520" marR="47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7520" rIns="4752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33±24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7520" marR="47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4160">
                <a:tc>
                  <a:txBody>
                    <a:bodyPr lIns="47520" rIns="47520" tIns="0" bIns="0" anchor="t">
                      <a:noAutofit/>
                    </a:bodyPr>
                    <a:p>
                      <a:pPr algn="just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CV seronegativ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7520" marR="47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7520" rIns="4752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3.7±53.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7520" marR="47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7520" rIns="4752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9.0±41.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7520" marR="47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7520" rIns="4752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8.6±34.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7520" marR="47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7520" rIns="4752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3.5±19.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7520" marR="47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7520" rIns="4752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005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±218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7520" marR="47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7520" rIns="4752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25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±44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7520" marR="47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5560">
                <a:tc>
                  <a:txBody>
                    <a:bodyPr lIns="47520" rIns="47520" tIns="0" bIns="0" anchor="t">
                      <a:noAutofit/>
                    </a:bodyPr>
                    <a:p>
                      <a:pPr algn="just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7520" marR="47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7520" rIns="4752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7520" marR="47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7520" rIns="4752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7520" marR="47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7520" rIns="4752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7520" marR="47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7520" rIns="4752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7520" marR="47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7520" rIns="4752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33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7520" marR="47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7520" rIns="4752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25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7520" marR="47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Rectangle 7"/>
          <p:cNvSpPr/>
          <p:nvPr/>
        </p:nvSpPr>
        <p:spPr>
          <a:xfrm>
            <a:off x="174960" y="765000"/>
            <a:ext cx="2066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i-FI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Table S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7-06T13:16:31Z</dcterms:created>
  <dc:creator>lab16 arun kumar</dc:creator>
  <dc:description/>
  <dc:language>en-US</dc:language>
  <cp:lastModifiedBy>lab16 arun kumar</cp:lastModifiedBy>
  <dcterms:modified xsi:type="dcterms:W3CDTF">2012-07-06T16:58:15Z</dcterms:modified>
  <cp:revision>23</cp:revision>
  <dc:subject/>
  <dc:title>Slide 1</dc:title>
</cp:coreProperties>
</file>